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56" r:id="rId3"/>
    <p:sldId id="262" r:id="rId4"/>
    <p:sldId id="263" r:id="rId5"/>
    <p:sldId id="264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6/07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6/07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Manhattan plots of genotyped and imputed genetic variants associated with (a) type 1 and (b) type 2 diabetes across the genome from the T1D Knowledge Portal</a:t>
            </a:r>
            <a:endParaRPr lang="en-GB" sz="2000" b="1" dirty="0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1EAF30B-A8BF-92A9-1379-903F09C4FF5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63688" y="1196752"/>
            <a:ext cx="5688632" cy="475134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45FE3FD-49F6-2BC9-A594-BB3FDAC46AC8}"/>
              </a:ext>
            </a:extLst>
          </p:cNvPr>
          <p:cNvSpPr txBox="1"/>
          <p:nvPr/>
        </p:nvSpPr>
        <p:spPr>
          <a:xfrm>
            <a:off x="107504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Luckett et al (2023) Diabetologia DOI 10.1007/s00125-023-05955-y </a:t>
            </a:r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ype 1 diabetes genetic risk includes common HLA variants with large effect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1B81EF6-37B2-567C-11A1-B1E7C3126D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9632" y="1245538"/>
            <a:ext cx="6047581" cy="434718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2279588-5342-F2B2-0B62-CD47A369238A}"/>
              </a:ext>
            </a:extLst>
          </p:cNvPr>
          <p:cNvSpPr txBox="1"/>
          <p:nvPr/>
        </p:nvSpPr>
        <p:spPr>
          <a:xfrm>
            <a:off x="107504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Luckett et al (2023) Diabetologia DOI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10.1007/s00125-023-05955-y </a:t>
            </a:r>
            <a:endParaRPr lang="en-GB" dirty="0"/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imeline of type 1 diabetes genetic risk score development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4CA4F01-CD3D-7A8B-E699-6F85A3C858C3}"/>
              </a:ext>
            </a:extLst>
          </p:cNvPr>
          <p:cNvSpPr txBox="1"/>
          <p:nvPr/>
        </p:nvSpPr>
        <p:spPr>
          <a:xfrm>
            <a:off x="107504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Luckett et al (2023) Diabetologia DOI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10.1007/s00125-023-05955-y </a:t>
            </a:r>
            <a:endParaRPr lang="en-GB" dirty="0"/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3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03A2CC2-80DC-EF59-BBAC-FACFF14B7E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1999" y="1015440"/>
            <a:ext cx="8549082" cy="48271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CC4A01C-06BE-8FB9-6F7E-399F4BDF0F9E}"/>
              </a:ext>
            </a:extLst>
          </p:cNvPr>
          <p:cNvSpPr txBox="1"/>
          <p:nvPr/>
        </p:nvSpPr>
        <p:spPr>
          <a:xfrm>
            <a:off x="395536" y="332656"/>
            <a:ext cx="82089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World map of genetic risk score model performance in predicting risk of type 1 diabetes, type 2 diabetes, MODY and latent autoimmune diabetes of adults (LADA)</a:t>
            </a:r>
            <a:endParaRPr lang="en-GB" sz="2000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5ECA8F3-9DCA-5E29-11D9-6EF9FE3E211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8239" y="1628800"/>
            <a:ext cx="8227521" cy="42138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EBDF3A8-7564-F2AB-B63F-43F38CAB39E9}"/>
              </a:ext>
            </a:extLst>
          </p:cNvPr>
          <p:cNvSpPr txBox="1"/>
          <p:nvPr/>
        </p:nvSpPr>
        <p:spPr>
          <a:xfrm>
            <a:off x="107504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Luckett et al (2023) Diabetologia DOI 10.1007/s00125-023-05955-y </a:t>
            </a:r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3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pic>
        <p:nvPicPr>
          <p:cNvPr id="6" name="Picture 5" descr="diabetologia logo.tif">
            <a:extLst>
              <a:ext uri="{FF2B5EF4-FFF2-40B4-BE49-F238E27FC236}">
                <a16:creationId xmlns:a16="http://schemas.microsoft.com/office/drawing/2014/main" id="{46F22355-0214-C490-A073-A7FF79064E8B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24585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85A651F-70EC-3940-D257-5EC2322F40D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1907" y="1658461"/>
            <a:ext cx="5980186" cy="424847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8CD679A-D819-78B3-2635-758E83C8D30B}"/>
              </a:ext>
            </a:extLst>
          </p:cNvPr>
          <p:cNvSpPr txBox="1"/>
          <p:nvPr/>
        </p:nvSpPr>
        <p:spPr>
          <a:xfrm>
            <a:off x="395536" y="332656"/>
            <a:ext cx="820891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chematic demonstrating the distribution of type 1 diabetes genetic </a:t>
            </a:r>
            <a:r>
              <a:rPr lang="en-US" sz="2000" b="1"/>
              <a:t>risk scores </a:t>
            </a:r>
            <a:r>
              <a:rPr lang="en-US" sz="2000" b="1" dirty="0"/>
              <a:t>for type 1 diabetes, type 2 diabetes, MODY and latent autoimmune diabetes of adults (LADA)</a:t>
            </a:r>
            <a:endParaRPr lang="en-GB" sz="2000" b="1" dirty="0"/>
          </a:p>
        </p:txBody>
      </p:sp>
      <p:pic>
        <p:nvPicPr>
          <p:cNvPr id="3" name="Picture 2" descr="diabetologia logo.tif">
            <a:extLst>
              <a:ext uri="{FF2B5EF4-FFF2-40B4-BE49-F238E27FC236}">
                <a16:creationId xmlns:a16="http://schemas.microsoft.com/office/drawing/2014/main" id="{D5C5F9F4-7443-21DF-ABF5-81C8E3AC004E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67557ED-55BC-5884-11E0-5464141F7C57}"/>
              </a:ext>
            </a:extLst>
          </p:cNvPr>
          <p:cNvSpPr txBox="1"/>
          <p:nvPr/>
        </p:nvSpPr>
        <p:spPr>
          <a:xfrm>
            <a:off x="107504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Luckett et al (2023) Diabetologia DOI 10.1007/s00125-023-05955-y </a:t>
            </a:r>
          </a:p>
          <a:p>
            <a:r>
              <a:rPr lang="en-GB" sz="1200" dirty="0"/>
              <a:t>© The Authors 2023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642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2</Words>
  <Application>Microsoft Office PowerPoint</Application>
  <PresentationFormat>On-screen Show (4:3)</PresentationFormat>
  <Paragraphs>21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7</cp:revision>
  <dcterms:created xsi:type="dcterms:W3CDTF">2016-06-15T12:53:43Z</dcterms:created>
  <dcterms:modified xsi:type="dcterms:W3CDTF">2023-07-06T10:47:48Z</dcterms:modified>
</cp:coreProperties>
</file>